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726" y="20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20/10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6712" y="3603644"/>
            <a:ext cx="2674852" cy="12345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3 CuadroTexto"/>
          <p:cNvSpPr txBox="1"/>
          <p:nvPr/>
        </p:nvSpPr>
        <p:spPr>
          <a:xfrm>
            <a:off x="1837395" y="3403522"/>
            <a:ext cx="7713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tyledon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1725" y="3603644"/>
            <a:ext cx="2677595" cy="12345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6 CuadroTexto"/>
          <p:cNvSpPr txBox="1"/>
          <p:nvPr/>
        </p:nvSpPr>
        <p:spPr>
          <a:xfrm>
            <a:off x="4785552" y="3403522"/>
            <a:ext cx="4427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1365" y="5208763"/>
            <a:ext cx="2677595" cy="12345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8 CuadroTexto"/>
          <p:cNvSpPr txBox="1"/>
          <p:nvPr/>
        </p:nvSpPr>
        <p:spPr>
          <a:xfrm>
            <a:off x="1972938" y="4944756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o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1168" y="5192862"/>
            <a:ext cx="2674852" cy="12345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10 CuadroTexto"/>
          <p:cNvSpPr txBox="1"/>
          <p:nvPr/>
        </p:nvSpPr>
        <p:spPr>
          <a:xfrm>
            <a:off x="4713041" y="4944756"/>
            <a:ext cx="6142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loem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3 CuadroTexto"/>
          <p:cNvSpPr txBox="1"/>
          <p:nvPr/>
        </p:nvSpPr>
        <p:spPr>
          <a:xfrm>
            <a:off x="789006" y="2854842"/>
            <a:ext cx="15135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lementa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11 CuadroTexto"/>
          <p:cNvSpPr txBox="1"/>
          <p:nvPr/>
        </p:nvSpPr>
        <p:spPr>
          <a:xfrm>
            <a:off x="1916009" y="4781377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ze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12 CuadroTexto"/>
          <p:cNvSpPr txBox="1"/>
          <p:nvPr/>
        </p:nvSpPr>
        <p:spPr>
          <a:xfrm>
            <a:off x="4717972" y="4779624"/>
            <a:ext cx="5709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ze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1920294" y="6389406"/>
            <a:ext cx="570990" cy="2662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ze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4722257" y="6387653"/>
            <a:ext cx="570990" cy="2662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ze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 rot="16200000">
            <a:off x="242604" y="4054728"/>
            <a:ext cx="10102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endogenous -</a:t>
            </a:r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 rot="16200000">
            <a:off x="242604" y="5672858"/>
            <a:ext cx="10102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endogenous -</a:t>
            </a:r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18 CuadroTexto"/>
          <p:cNvSpPr txBox="1"/>
          <p:nvPr/>
        </p:nvSpPr>
        <p:spPr>
          <a:xfrm rot="16200000">
            <a:off x="3034633" y="4054728"/>
            <a:ext cx="10102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endogenous -</a:t>
            </a:r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19 CuadroTexto"/>
          <p:cNvSpPr txBox="1"/>
          <p:nvPr/>
        </p:nvSpPr>
        <p:spPr>
          <a:xfrm rot="16200000">
            <a:off x="3042647" y="5672858"/>
            <a:ext cx="10102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endogenous -</a:t>
            </a:r>
            <a:r>
              <a:rPr lang="en-US" sz="7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NA</a:t>
            </a:r>
            <a:r>
              <a:rPr lang="en-US" sz="7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71516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8</TotalTime>
  <Words>31</Words>
  <Application>Microsoft Office PowerPoint</Application>
  <PresentationFormat>Presentación en pantalla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Carmen</dc:creator>
  <cp:lastModifiedBy>MariCarmen</cp:lastModifiedBy>
  <cp:revision>4</cp:revision>
  <dcterms:created xsi:type="dcterms:W3CDTF">2014-04-11T09:58:57Z</dcterms:created>
  <dcterms:modified xsi:type="dcterms:W3CDTF">2014-10-20T15:06:27Z</dcterms:modified>
</cp:coreProperties>
</file>